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263" r:id="rId2"/>
    <p:sldId id="268" r:id="rId3"/>
    <p:sldId id="264" r:id="rId4"/>
    <p:sldId id="267" r:id="rId5"/>
    <p:sldId id="257" r:id="rId6"/>
    <p:sldId id="258" r:id="rId7"/>
    <p:sldId id="259" r:id="rId8"/>
    <p:sldId id="260" r:id="rId9"/>
    <p:sldId id="262" r:id="rId10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08FB837D-C827-4EFA-A057-4D05807E0F7C}" styleName="Themed Style 1 - Accent 6">
    <a:tblBg>
      <a:fillRef idx="2">
        <a:schemeClr val="accent6"/>
      </a:fillRef>
      <a:effectRef idx="1">
        <a:schemeClr val="accent6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Ref idx="1">
              <a:schemeClr val="accent6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  <a:fill>
          <a:solidFill>
            <a:schemeClr val="accent6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6"/>
            </a:lnRef>
          </a:left>
          <a:right>
            <a:lnRef idx="2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2">
              <a:schemeClr val="accent6"/>
            </a:lnRef>
          </a:top>
          <a:bottom>
            <a:lnRef idx="2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firstRow>
  </a:tblStyle>
  <a:tblStyle styleId="{69C7853C-536D-4A76-A0AE-DD22124D55A5}" styleName="Themed Style 1 - Accent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2" d="100"/>
          <a:sy n="62" d="100"/>
        </p:scale>
        <p:origin x="804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1B331A4-FEDA-4DED-92B9-56B242D61E00}" type="datetimeFigureOut">
              <a:rPr lang="en-US" smtClean="0"/>
              <a:t>6/5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737C8F2-45BA-4511-93B7-9F53CF3FEA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416102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737C8F2-45BA-4511-93B7-9F53CF3FEAF6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74308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737C8F2-45BA-4511-93B7-9F53CF3FEAF6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973127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30B445-4620-4D11-904C-F1FAAD65F05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DE5E039-9B1C-4461-AA85-974C14F5E61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286A20-AAB1-43F7-AC96-A01E4C8611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B75DB-BE8C-4A24-9F62-6B39BE259D81}" type="datetimeFigureOut">
              <a:rPr lang="en-US" smtClean="0"/>
              <a:t>6/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3EFA18-F8B0-49BF-89A7-A53419B07E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9B8B2C-8C08-42B6-824A-3378E41F67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FB93D-D2B2-486C-98AF-FC6FFB1C9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947192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743066-1F86-4001-A4DD-62913BB1A4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BFD22F4-D388-46F4-8077-D6800DB10E4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3014BE-19E7-4016-85A7-6ED3B1FAA4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B75DB-BE8C-4A24-9F62-6B39BE259D81}" type="datetimeFigureOut">
              <a:rPr lang="en-US" smtClean="0"/>
              <a:t>6/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97A985-6FA4-49CF-B54B-3332A7B673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415D1A-661B-4FB8-BAC4-7DE0B69568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FB93D-D2B2-486C-98AF-FC6FFB1C9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43180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D2618D5-2B44-4D61-A9CE-477D12381BA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900BB4D-40A2-4614-94A7-E26065294FC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67B86B-4F1C-4127-A8B5-524AA7D9CF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B75DB-BE8C-4A24-9F62-6B39BE259D81}" type="datetimeFigureOut">
              <a:rPr lang="en-US" smtClean="0"/>
              <a:t>6/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4BD3E1-DE9E-43E7-ADE7-7D431737FB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4BAAD2-FD5D-4192-8D50-D37415296A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FB93D-D2B2-486C-98AF-FC6FFB1C9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99207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B94CE5-84FD-42CA-8BFA-A92B2D3031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635D3F8-371B-468B-9FBB-C526B455D7E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436D30-874F-4753-997B-5269EA16BE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B75DB-BE8C-4A24-9F62-6B39BE259D81}" type="datetimeFigureOut">
              <a:rPr lang="en-US" smtClean="0"/>
              <a:t>6/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F18B00-7689-4E0D-96DB-434F61EDBD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299F165-D42A-4B6E-9DDE-234A713E4C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FB93D-D2B2-486C-98AF-FC6FFB1C9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83287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6CBE953-BA2D-48A5-9314-0C17AD0628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96A732E-519A-4874-A68B-AFB45EDA12B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536EA22-5D46-4729-A997-698A203B95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B75DB-BE8C-4A24-9F62-6B39BE259D81}" type="datetimeFigureOut">
              <a:rPr lang="en-US" smtClean="0"/>
              <a:t>6/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74BD24-E743-4BF9-B07E-B429D9F07E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3C64B7-059C-4339-92FD-B4E1C0944C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FB93D-D2B2-486C-98AF-FC6FFB1C9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90642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93A06E-EC43-4B20-85F7-5A6B4DB9D6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CD023E6-4220-420A-AEFF-4F8B0224F37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942CF06-15AD-46DE-8D30-FE2212B146A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1571F2D-83D6-4FBE-B50A-35B8A6307B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B75DB-BE8C-4A24-9F62-6B39BE259D81}" type="datetimeFigureOut">
              <a:rPr lang="en-US" smtClean="0"/>
              <a:t>6/5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541BD28-020F-40FB-956B-BDA35F178F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876C6E1-B205-4544-9043-CACDF983D8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FB93D-D2B2-486C-98AF-FC6FFB1C9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79817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063B78-149F-4A83-BC55-1F9723C45A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DD7BE27-1C15-4D3D-8F00-F467E11834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CECE3AC-A782-4F3C-BCE8-185BF63D985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20E494F-FFA9-4A6B-AC7D-ADD269239FD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8F5D2E6-0801-4512-93C7-063C4BF6F54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221878B-3995-4915-AA3D-918D5AB3E0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B75DB-BE8C-4A24-9F62-6B39BE259D81}" type="datetimeFigureOut">
              <a:rPr lang="en-US" smtClean="0"/>
              <a:t>6/5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CCF5DB0-DE2C-4688-B3C1-7C772ECE91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77917F6-A0F9-4738-8301-B352A64AB8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FB93D-D2B2-486C-98AF-FC6FFB1C9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40492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DA1C6A-C203-46CE-8689-44C8257334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925B349-2FDA-485B-8331-6AE1F5F6D1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B75DB-BE8C-4A24-9F62-6B39BE259D81}" type="datetimeFigureOut">
              <a:rPr lang="en-US" smtClean="0"/>
              <a:t>6/5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AB94EBB-ABC5-4863-9F81-E7AB5F434F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697F759-3601-458A-9C8E-28FEBB5A10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FB93D-D2B2-486C-98AF-FC6FFB1C9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77920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DD3AD44-503A-4127-8086-2DC056278D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B75DB-BE8C-4A24-9F62-6B39BE259D81}" type="datetimeFigureOut">
              <a:rPr lang="en-US" smtClean="0"/>
              <a:t>6/5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B90A082-104B-4776-89CF-DD5E0D4334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D2853CD-39AC-4996-ABBE-9020E8B0A1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FB93D-D2B2-486C-98AF-FC6FFB1C9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60108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F7C3C4-03CF-4AFF-8021-24622010B0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9DBDF1E-F5B5-4679-8132-A7A8B4C3D9F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B155CED-259B-44FD-AC3E-107CFAF6B1D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C12E145-9D19-4026-B175-0048D56CA9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B75DB-BE8C-4A24-9F62-6B39BE259D81}" type="datetimeFigureOut">
              <a:rPr lang="en-US" smtClean="0"/>
              <a:t>6/5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3AD524F-F028-404E-9D0E-9FDAF1A551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39AB13B-2472-443E-9A06-136271D68C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FB93D-D2B2-486C-98AF-FC6FFB1C9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75358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245BC1-4A90-4321-A054-A4448E8998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7EA827B-4D2B-46BC-B679-748320D09FA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0A1499D-FFCD-4C8F-885D-613C4226E6E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BCD222F-9D41-4377-9A50-D1F15A0DFD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1B75DB-BE8C-4A24-9F62-6B39BE259D81}" type="datetimeFigureOut">
              <a:rPr lang="en-US" smtClean="0"/>
              <a:t>6/5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481B044-15F2-4D64-AB85-074DBD90EC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393C0B7-7459-4402-8D13-1DA68A8543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5FB93D-D2B2-486C-98AF-FC6FFB1C9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21849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E072EBC-01BC-42D4-90CF-9EF66E2D1F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BE81AB5-281B-48AD-8E42-4C92B78812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852CA0-41E6-404F-822C-513640FC370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1B75DB-BE8C-4A24-9F62-6B39BE259D81}" type="datetimeFigureOut">
              <a:rPr lang="en-US" smtClean="0"/>
              <a:t>6/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8D2AE9-FB85-4D62-B3AD-7320B22BCCB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60D488-36B3-41BA-A771-DE144A194DF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5FB93D-D2B2-486C-98AF-FC6FFB1C9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92785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B604C3-931C-4A51-940D-BC361698E362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b="1" dirty="0"/>
              <a:t>Supplementary files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9B50C6B-032E-4BCD-B24F-A0E79413215A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53140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C76B5CF-0E74-4612-A497-5C669B35D4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24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1: Progression-free survival and DCAF&gt;3%</a:t>
            </a:r>
            <a:br>
              <a:rPr lang="en-US" sz="2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</a:b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Content Placeholder 6" descr="Chart&#10;&#10;Description automatically generated">
            <a:extLst>
              <a:ext uri="{FF2B5EF4-FFF2-40B4-BE49-F238E27FC236}">
                <a16:creationId xmlns:a16="http://schemas.microsoft.com/office/drawing/2014/main" id="{6D2EF956-022D-446D-B056-5F4BF215A57B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8116" y="1253331"/>
            <a:ext cx="9443299" cy="5311856"/>
          </a:xfrm>
        </p:spPr>
      </p:pic>
    </p:spTree>
    <p:extLst>
      <p:ext uri="{BB962C8B-B14F-4D97-AF65-F5344CB8AC3E}">
        <p14:creationId xmlns:p14="http://schemas.microsoft.com/office/powerpoint/2010/main" val="106576177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10D2AE-A6EA-4257-AB52-E4043D9521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7912" y="0"/>
            <a:ext cx="10515600" cy="1325563"/>
          </a:xfrm>
        </p:spPr>
        <p:txBody>
          <a:bodyPr>
            <a:normAutofit/>
          </a:bodyPr>
          <a:lstStyle/>
          <a:p>
            <a:r>
              <a:rPr lang="en-US" sz="24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upplementary figure 2: Progression-free survival and DCAF quartiles</a:t>
            </a:r>
            <a:endParaRPr lang="en-US" sz="2400" dirty="0"/>
          </a:p>
        </p:txBody>
      </p:sp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FD500813-2E44-45A2-9BC8-BB9BB8C4FA24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10244" t="28943" r="11527" b="8315"/>
          <a:stretch/>
        </p:blipFill>
        <p:spPr>
          <a:xfrm>
            <a:off x="811658" y="1212350"/>
            <a:ext cx="10397447" cy="5229546"/>
          </a:xfr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206CC8F1-204D-4B64-9341-70428A5EDB1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55160" y="1442390"/>
            <a:ext cx="4561185" cy="13255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1424599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F428B0-660A-4B88-9153-B92FEA78DE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8187" y="0"/>
            <a:ext cx="10515600" cy="1325563"/>
          </a:xfrm>
        </p:spPr>
        <p:txBody>
          <a:bodyPr>
            <a:normAutofit/>
          </a:bodyPr>
          <a:lstStyle/>
          <a:p>
            <a:r>
              <a:rPr lang="en-US" sz="24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3: Overall survival and DCAF quartiles</a:t>
            </a:r>
            <a:br>
              <a:rPr lang="en-US" sz="24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</a:br>
            <a:endParaRPr lang="en-US" sz="2400" dirty="0"/>
          </a:p>
        </p:txBody>
      </p:sp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724A60D3-14AE-4065-A178-45C26CD62EAA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2"/>
          <a:srcRect l="9978" t="32196" r="11926" b="6661"/>
          <a:stretch/>
        </p:blipFill>
        <p:spPr>
          <a:xfrm>
            <a:off x="390419" y="924871"/>
            <a:ext cx="11308458" cy="5619767"/>
          </a:xfr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E4F5EC8F-854B-47CB-A1BB-F6C708D43A3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83287" y="1006148"/>
            <a:ext cx="4715590" cy="13704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1919143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2F86F8-DACD-444F-AF4D-E40FF6D0C0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:</a:t>
            </a:r>
            <a:r>
              <a:rPr lang="en-US" sz="24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t</a:t>
            </a:r>
            <a:r>
              <a:rPr lang="en-US" sz="24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DNA Response vs. Non−Response. p = 0.2678</a:t>
            </a:r>
            <a:br>
              <a:rPr lang="en-US" sz="24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</a:b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C15FB27A-4C35-45DD-A270-0F4B5D7C6404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3702310" y="1825625"/>
            <a:ext cx="4787380" cy="43513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0033005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565099-6C9C-4C92-A01D-B33C5DE10A4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: </a:t>
            </a:r>
            <a:r>
              <a:rPr lang="en-US" sz="2400" b="1" dirty="0">
                <a:latin typeface="Arial" panose="020B0604020202020204" pitchFamily="34" charset="0"/>
              </a:rPr>
              <a:t>ct</a:t>
            </a:r>
            <a:r>
              <a:rPr lang="en-US" sz="2400" b="1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DNA Disease Control vs. </a:t>
            </a:r>
            <a:r>
              <a:rPr lang="en-US" sz="2400" b="1" dirty="0">
                <a:latin typeface="Arial" panose="020B0604020202020204" pitchFamily="34" charset="0"/>
                <a:ea typeface="Arial" panose="020B0604020202020204" pitchFamily="34" charset="0"/>
              </a:rPr>
              <a:t>Disease progression.</a:t>
            </a:r>
            <a:r>
              <a:rPr lang="en-US" sz="2400" b="1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  <a:t> p = 0.0843</a:t>
            </a:r>
            <a:br>
              <a:rPr lang="en-US" sz="2400" b="1" dirty="0">
                <a:effectLst/>
                <a:latin typeface="Arial" panose="020B0604020202020204" pitchFamily="34" charset="0"/>
                <a:ea typeface="Arial" panose="020B0604020202020204" pitchFamily="34" charset="0"/>
              </a:rPr>
            </a:br>
            <a:endParaRPr lang="en-US" sz="2400" b="1" dirty="0"/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1CED6E80-427A-4C4F-9971-BEC60FC1A05A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3706304" y="1825625"/>
            <a:ext cx="4779392" cy="43513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598463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D39589-B44E-409C-9374-10AFCA753E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6: </a:t>
            </a:r>
            <a:r>
              <a:rPr lang="en-US" sz="24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t</a:t>
            </a:r>
            <a:r>
              <a:rPr lang="en-US" sz="24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DNA by Group. p = 0.1373</a:t>
            </a:r>
            <a:br>
              <a:rPr lang="en-US" sz="24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</a:b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Content Placeholder 3">
            <a:extLst>
              <a:ext uri="{FF2B5EF4-FFF2-40B4-BE49-F238E27FC236}">
                <a16:creationId xmlns:a16="http://schemas.microsoft.com/office/drawing/2014/main" id="{2455EC35-D34B-4B03-9DD0-34B714EF2761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3706304" y="1825625"/>
            <a:ext cx="4779392" cy="43513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9382201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E83043-A33A-4A63-9D1E-CF18FF2B04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11476" y="0"/>
            <a:ext cx="10515600" cy="1325563"/>
          </a:xfrm>
        </p:spPr>
        <p:txBody>
          <a:bodyPr>
            <a:norm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7: CA19-9 and DCAF impact on PFS</a:t>
            </a:r>
          </a:p>
        </p:txBody>
      </p:sp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07101F86-51B9-4523-91AE-404AF7C1E48E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3"/>
          <a:srcRect l="23226" t="38201" r="24941" b="18088"/>
          <a:stretch/>
        </p:blipFill>
        <p:spPr>
          <a:xfrm>
            <a:off x="595901" y="1202076"/>
            <a:ext cx="10880332" cy="5363111"/>
          </a:xfrm>
        </p:spPr>
      </p:pic>
    </p:spTree>
    <p:extLst>
      <p:ext uri="{BB962C8B-B14F-4D97-AF65-F5344CB8AC3E}">
        <p14:creationId xmlns:p14="http://schemas.microsoft.com/office/powerpoint/2010/main" val="192247020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E83043-A33A-4A63-9D1E-CF18FF2B04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11476" y="0"/>
            <a:ext cx="10515600" cy="1325563"/>
          </a:xfrm>
        </p:spPr>
        <p:txBody>
          <a:bodyPr>
            <a:norm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8: CA19-9 and DCAF impact on OS</a:t>
            </a:r>
          </a:p>
        </p:txBody>
      </p:sp>
      <p:pic>
        <p:nvPicPr>
          <p:cNvPr id="7" name="Content Placeholder 6">
            <a:extLst>
              <a:ext uri="{FF2B5EF4-FFF2-40B4-BE49-F238E27FC236}">
                <a16:creationId xmlns:a16="http://schemas.microsoft.com/office/drawing/2014/main" id="{654DEE6F-93D3-44B8-A13F-89E42C04F24A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 rotWithShape="1">
          <a:blip r:embed="rId3"/>
          <a:srcRect l="23227" t="49657" r="24543" b="6189"/>
          <a:stretch/>
        </p:blipFill>
        <p:spPr>
          <a:xfrm>
            <a:off x="543159" y="1232756"/>
            <a:ext cx="11105682" cy="5281059"/>
          </a:xfrm>
        </p:spPr>
      </p:pic>
    </p:spTree>
    <p:extLst>
      <p:ext uri="{BB962C8B-B14F-4D97-AF65-F5344CB8AC3E}">
        <p14:creationId xmlns:p14="http://schemas.microsoft.com/office/powerpoint/2010/main" val="9390727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6</TotalTime>
  <Words>99</Words>
  <Application>Microsoft Office PowerPoint</Application>
  <PresentationFormat>Widescreen</PresentationFormat>
  <Paragraphs>11</Paragraphs>
  <Slides>9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3" baseType="lpstr">
      <vt:lpstr>Arial</vt:lpstr>
      <vt:lpstr>Calibri</vt:lpstr>
      <vt:lpstr>Calibri Light</vt:lpstr>
      <vt:lpstr>Office Theme</vt:lpstr>
      <vt:lpstr>Supplementary files</vt:lpstr>
      <vt:lpstr>Supplementary figure 1: Progression-free survival and DCAF&gt;3% </vt:lpstr>
      <vt:lpstr>Supplementary figure 2: Progression-free survival and DCAF quartiles</vt:lpstr>
      <vt:lpstr>Supplementary figure 3: Overall survival and DCAF quartiles </vt:lpstr>
      <vt:lpstr>Supplementary figure 4:ctDNA Response vs. Non−Response. p = 0.2678 </vt:lpstr>
      <vt:lpstr>Supplementary figure 5: ctDNA Disease Control vs. Disease progression. p = 0.0843 </vt:lpstr>
      <vt:lpstr>Supplementary figure 6: ctDNA by Group. p = 0.1373 </vt:lpstr>
      <vt:lpstr>Supplementary figure 7: CA19-9 and DCAF impact on PFS</vt:lpstr>
      <vt:lpstr>Supplementary figure 8: CA19-9 and DCAF impact on O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 1</dc:title>
  <dc:creator>PEDRO USON</dc:creator>
  <cp:lastModifiedBy>PEDRO USON</cp:lastModifiedBy>
  <cp:revision>26</cp:revision>
  <dcterms:created xsi:type="dcterms:W3CDTF">2021-05-05T18:49:13Z</dcterms:created>
  <dcterms:modified xsi:type="dcterms:W3CDTF">2021-06-06T02:07:25Z</dcterms:modified>
</cp:coreProperties>
</file>